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wmf" ContentType="image/x-wmf"/>
  <Override PartName="/ppt/media/image13.wmf" ContentType="image/x-wmf"/>
  <Override PartName="/ppt/media/image8.wmf" ContentType="image/x-wmf"/>
  <Override PartName="/ppt/media/image12.wmf" ContentType="image/x-wmf"/>
  <Override PartName="/ppt/media/image7.wmf" ContentType="image/x-wmf"/>
  <Override PartName="/ppt/media/image11.wmf" ContentType="image/x-wmf"/>
  <Override PartName="/ppt/media/image6.wmf" ContentType="image/x-wmf"/>
  <Override PartName="/ppt/media/image10.wmf" ContentType="image/x-wmf"/>
  <Override PartName="/ppt/media/image5.wmf" ContentType="image/x-wmf"/>
  <Override PartName="/ppt/media/image4.wmf" ContentType="image/x-wmf"/>
  <Override PartName="/ppt/media/image23.wmf" ContentType="image/x-wmf"/>
  <Override PartName="/ppt/media/image22.wmf" ContentType="image/x-wmf"/>
  <Override PartName="/ppt/media/image21.wmf" ContentType="image/x-wmf"/>
  <Override PartName="/ppt/media/image19.wmf" ContentType="image/x-wmf"/>
  <Override PartName="/ppt/media/image1.wmf" ContentType="image/x-wmf"/>
  <Override PartName="/ppt/media/image3.wmf" ContentType="image/x-wmf"/>
  <Override PartName="/ppt/media/image20.wmf" ContentType="image/x-wmf"/>
  <Override PartName="/ppt/media/image18.wmf" ContentType="image/x-wmf"/>
  <Override PartName="/ppt/media/image17.wmf" ContentType="image/x-wmf"/>
  <Override PartName="/ppt/media/image16.wmf" ContentType="image/x-wmf"/>
  <Override PartName="/ppt/media/image15.wmf" ContentType="image/x-wmf"/>
  <Override PartName="/ppt/media/image14.wmf" ContentType="image/x-wmf"/>
  <Override PartName="/ppt/media/image2.wmf" ContentType="image/x-wmf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8640763" cy="144033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09F6BD-D06E-443C-AE13-59DAC2A8CF3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31640" y="576000"/>
            <a:ext cx="7777440" cy="2400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31640" y="3360240"/>
            <a:ext cx="7777440" cy="453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31640" y="8324640"/>
            <a:ext cx="7777440" cy="453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C84C83-F4BE-48F3-97FE-788D87A7F60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31640" y="576000"/>
            <a:ext cx="7777440" cy="2400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31640" y="3360240"/>
            <a:ext cx="3795120" cy="453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416840" y="3360240"/>
            <a:ext cx="3795120" cy="453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31640" y="8324640"/>
            <a:ext cx="3795120" cy="453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416840" y="8324640"/>
            <a:ext cx="3795120" cy="453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60ABFE-5E97-4428-B3E8-5ACBDD002C0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31640" y="576000"/>
            <a:ext cx="7777440" cy="2400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31640" y="3360240"/>
            <a:ext cx="2504160" cy="453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061440" y="3360240"/>
            <a:ext cx="2504160" cy="453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691240" y="3360240"/>
            <a:ext cx="2504160" cy="453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31640" y="8324640"/>
            <a:ext cx="2504160" cy="453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061440" y="8324640"/>
            <a:ext cx="2504160" cy="453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691240" y="8324640"/>
            <a:ext cx="2504160" cy="453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671BF7-2046-4C69-BB88-5F15A046B64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31640" y="576000"/>
            <a:ext cx="7777440" cy="2400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31640" y="3360240"/>
            <a:ext cx="7777440" cy="9504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C92393-16DB-441F-B726-AD51097EBCF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31640" y="576000"/>
            <a:ext cx="7777440" cy="2400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31640" y="3360240"/>
            <a:ext cx="7777440" cy="9504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F0BCEB-D85C-411D-8DDA-EDB953B21C1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31640" y="576000"/>
            <a:ext cx="7777440" cy="2400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31640" y="3360240"/>
            <a:ext cx="3795120" cy="9504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416840" y="3360240"/>
            <a:ext cx="3795120" cy="9504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F11605-31C9-4CAB-9A48-E8955230BF3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31640" y="576000"/>
            <a:ext cx="7777440" cy="2400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CFE205-0EEF-4FEA-9145-19729DD8642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31640" y="576000"/>
            <a:ext cx="7777440" cy="11126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44C2B9-59FB-4504-8049-266E6F33900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31640" y="576000"/>
            <a:ext cx="7777440" cy="2400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31640" y="3360240"/>
            <a:ext cx="3795120" cy="453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416840" y="3360240"/>
            <a:ext cx="3795120" cy="9504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31640" y="8324640"/>
            <a:ext cx="3795120" cy="453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021FA3-8C40-4273-8123-07833DF4DDE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31640" y="576000"/>
            <a:ext cx="7777440" cy="2400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31640" y="3360240"/>
            <a:ext cx="3795120" cy="9504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416840" y="3360240"/>
            <a:ext cx="3795120" cy="453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416840" y="8324640"/>
            <a:ext cx="3795120" cy="453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039840-20AC-4EF3-992E-A5DEA1B582A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31640" y="576000"/>
            <a:ext cx="7777440" cy="2400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31640" y="3360240"/>
            <a:ext cx="3795120" cy="453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416840" y="3360240"/>
            <a:ext cx="3795120" cy="453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31640" y="8324640"/>
            <a:ext cx="7777440" cy="453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152991-96EF-49B5-B16D-245E63E81A9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31640" y="576000"/>
            <a:ext cx="7777440" cy="2400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맑은 고딕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31640" y="3360240"/>
            <a:ext cx="7777440" cy="9504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31280" y="13347720"/>
            <a:ext cx="2016360" cy="76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952720" y="13347720"/>
            <a:ext cx="2735280" cy="76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192360" y="13347720"/>
            <a:ext cx="2016360" cy="76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E4E77EF-A814-4EBD-B97A-C6B5B9A61EF5}" type="slidenum">
              <a: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wmf"/><Relationship Id="rId4" Type="http://schemas.openxmlformats.org/officeDocument/2006/relationships/image" Target="../media/image4.wmf"/><Relationship Id="rId5" Type="http://schemas.openxmlformats.org/officeDocument/2006/relationships/image" Target="../media/image5.wmf"/><Relationship Id="rId6" Type="http://schemas.openxmlformats.org/officeDocument/2006/relationships/image" Target="../media/image6.wmf"/><Relationship Id="rId7" Type="http://schemas.openxmlformats.org/officeDocument/2006/relationships/image" Target="../media/image7.wmf"/><Relationship Id="rId8" Type="http://schemas.openxmlformats.org/officeDocument/2006/relationships/image" Target="../media/image8.wmf"/><Relationship Id="rId9" Type="http://schemas.openxmlformats.org/officeDocument/2006/relationships/image" Target="../media/image9.wmf"/><Relationship Id="rId10" Type="http://schemas.openxmlformats.org/officeDocument/2006/relationships/image" Target="../media/image10.wmf"/><Relationship Id="rId11" Type="http://schemas.openxmlformats.org/officeDocument/2006/relationships/image" Target="../media/image11.wmf"/><Relationship Id="rId12" Type="http://schemas.openxmlformats.org/officeDocument/2006/relationships/image" Target="../media/image12.wmf"/><Relationship Id="rId13" Type="http://schemas.openxmlformats.org/officeDocument/2006/relationships/image" Target="../media/image13.wmf"/><Relationship Id="rId14" Type="http://schemas.openxmlformats.org/officeDocument/2006/relationships/image" Target="../media/image14.wmf"/><Relationship Id="rId15" Type="http://schemas.openxmlformats.org/officeDocument/2006/relationships/image" Target="../media/image15.wmf"/><Relationship Id="rId16" Type="http://schemas.openxmlformats.org/officeDocument/2006/relationships/image" Target="../media/image16.wmf"/><Relationship Id="rId17" Type="http://schemas.openxmlformats.org/officeDocument/2006/relationships/image" Target="../media/image17.wmf"/><Relationship Id="rId18" Type="http://schemas.openxmlformats.org/officeDocument/2006/relationships/image" Target="../media/image18.wmf"/><Relationship Id="rId19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9.wmf"/><Relationship Id="rId2" Type="http://schemas.openxmlformats.org/officeDocument/2006/relationships/image" Target="../media/image20.wmf"/><Relationship Id="rId3" Type="http://schemas.openxmlformats.org/officeDocument/2006/relationships/image" Target="../media/image21.wmf"/><Relationship Id="rId4" Type="http://schemas.openxmlformats.org/officeDocument/2006/relationships/image" Target="../media/image22.wmf"/><Relationship Id="rId5" Type="http://schemas.openxmlformats.org/officeDocument/2006/relationships/image" Target="../media/image23.wmf"/><Relationship Id="rId6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270000" y="20520"/>
          <a:ext cx="8100720" cy="14328720"/>
        </p:xfrm>
        <a:graphic>
          <a:graphicData uri="http://schemas.openxmlformats.org/drawingml/2006/table">
            <a:tbl>
              <a:tblPr/>
              <a:tblGrid>
                <a:gridCol w="809640"/>
                <a:gridCol w="1224000"/>
                <a:gridCol w="2160360"/>
                <a:gridCol w="855720"/>
                <a:gridCol w="1214280"/>
                <a:gridCol w="1836720"/>
              </a:tblGrid>
              <a:tr h="835200"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Spot No: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Accession No: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Protein nam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맑은 고딕"/>
                          <a:ea typeface="맑은 고딕"/>
                        </a:rPr>
                        <a:t>p -valu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Fold chang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맑은 고딕"/>
                          <a:ea typeface="맑은 고딕"/>
                        </a:rPr>
                        <a:t>Relative spot intensity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556920"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90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Gi|3038785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Hypothalamic parathyroid hormon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  <a:ea typeface="맑은 고딕"/>
                        </a:rPr>
                        <a:t>0.034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1.9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113480"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918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GFPTI_ RAT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Glatamine –fructose-6 phosphate aminotransferase (isomerizing)1 o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  <a:ea typeface="맑은 고딕"/>
                        </a:rPr>
                        <a:t>0.005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2.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799200"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1539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PDIA3_ RAT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Protein disulfide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isomerase A3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  <a:ea typeface="맑은 고딕"/>
                        </a:rPr>
                        <a:t>2.012e-004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1.8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799200"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231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HSPB1_RAT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Heat shock protein beta 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  <a:ea typeface="맑은 고딕"/>
                        </a:rPr>
                        <a:t>0.004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2.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799200"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1049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ENPL_ RAT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Endoplasmin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  <a:ea typeface="맑은 고딕"/>
                        </a:rPr>
                        <a:t>0.003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2.3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835200"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1934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Gi|1359195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Guanine nucleotide-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binding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protein subunit alpha-1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  <a:ea typeface="맑은 고딕"/>
                        </a:rPr>
                        <a:t>0.00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2.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799200"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3043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Gi| 149036434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Rcg56127, isoform CRA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0.01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2.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799200"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1785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Gi|402534525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Microtubule-actin cross-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linking factor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  <a:ea typeface="맑은 고딕"/>
                        </a:rPr>
                        <a:t>0.035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1.8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799200"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887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ILK_RAT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   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Integrin-linked protein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kinas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0.007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2.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799200"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1425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MYRIP_RAT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Rab effector Myrip o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  <a:ea typeface="맑은 고딕"/>
                        </a:rPr>
                        <a:t>0.005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3.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799200"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128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Gi| 149046197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Myosin Ib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  <a:ea typeface="맑은 고딕"/>
                        </a:rPr>
                        <a:t>0.02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1.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799200"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2048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ALDR_RAT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Aldose reductas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  <a:ea typeface="맑은 고딕"/>
                        </a:rPr>
                        <a:t>0.023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1.7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799200"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967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ECHP_RAT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Peroxisomal bifunctional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enzym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  <a:ea typeface="맑은 고딕"/>
                        </a:rPr>
                        <a:t>0.024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2.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799200"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1422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Gi| 149024463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Cililary rootlet coiled–coil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rootletin (predicted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0.018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2.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799200"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179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SOCS1_ RAT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Cytokine inducible SH2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containing protein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  <a:ea typeface="맑은 고딕"/>
                        </a:rPr>
                        <a:t>0.00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2.3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799200"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179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PALM_RAT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Paralemmin -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  <a:ea typeface="맑은 고딕"/>
                        </a:rPr>
                        <a:t>9.306e-004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2.4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799200"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1433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MYH7_RAT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Myosin 7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  <a:ea typeface="맑은 고딕"/>
                        </a:rPr>
                        <a:t>0.04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2.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077480"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128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ANXA2_RAT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ANNEXIN  A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  <a:ea typeface="맑은 고딕"/>
                        </a:rPr>
                        <a:t>0.01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2.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pic>
        <p:nvPicPr>
          <p:cNvPr id="42" name="Picture 9" descr=""/>
          <p:cNvPicPr/>
          <p:nvPr/>
        </p:nvPicPr>
        <p:blipFill>
          <a:blip r:embed="rId1"/>
          <a:srcRect l="32955" t="29973" r="5687" b="0"/>
          <a:stretch/>
        </p:blipFill>
        <p:spPr>
          <a:xfrm>
            <a:off x="6892920" y="830160"/>
            <a:ext cx="1214280" cy="71748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4" descr=""/>
          <p:cNvPicPr/>
          <p:nvPr/>
        </p:nvPicPr>
        <p:blipFill>
          <a:blip r:embed="rId2"/>
          <a:srcRect l="72328" t="70651" r="0" b="0"/>
          <a:stretch/>
        </p:blipFill>
        <p:spPr>
          <a:xfrm>
            <a:off x="6964200" y="1500120"/>
            <a:ext cx="1293840" cy="808200"/>
          </a:xfrm>
          <a:prstGeom prst="rect">
            <a:avLst/>
          </a:prstGeom>
          <a:ln w="0">
            <a:noFill/>
          </a:ln>
        </p:spPr>
      </p:pic>
      <p:pic>
        <p:nvPicPr>
          <p:cNvPr id="44" name="Picture 3" descr=""/>
          <p:cNvPicPr/>
          <p:nvPr/>
        </p:nvPicPr>
        <p:blipFill>
          <a:blip r:embed="rId3"/>
          <a:srcRect l="76849" t="71685" r="0" b="5289"/>
          <a:stretch/>
        </p:blipFill>
        <p:spPr>
          <a:xfrm>
            <a:off x="6939000" y="2317680"/>
            <a:ext cx="1171440" cy="642960"/>
          </a:xfrm>
          <a:prstGeom prst="rect">
            <a:avLst/>
          </a:prstGeom>
          <a:ln w="0">
            <a:noFill/>
          </a:ln>
        </p:spPr>
      </p:pic>
      <p:pic>
        <p:nvPicPr>
          <p:cNvPr id="45" name="Picture 2" descr=""/>
          <p:cNvPicPr/>
          <p:nvPr/>
        </p:nvPicPr>
        <p:blipFill>
          <a:blip r:embed="rId4"/>
          <a:srcRect l="31067" t="50422" r="35652" b="0"/>
          <a:stretch/>
        </p:blipFill>
        <p:spPr>
          <a:xfrm>
            <a:off x="7004160" y="3208320"/>
            <a:ext cx="1108080" cy="571680"/>
          </a:xfrm>
          <a:prstGeom prst="rect">
            <a:avLst/>
          </a:prstGeom>
          <a:ln w="0">
            <a:noFill/>
          </a:ln>
        </p:spPr>
      </p:pic>
      <p:pic>
        <p:nvPicPr>
          <p:cNvPr id="46" name="Picture 7" descr=""/>
          <p:cNvPicPr/>
          <p:nvPr/>
        </p:nvPicPr>
        <p:blipFill>
          <a:blip r:embed="rId5"/>
          <a:srcRect l="62195" t="69821" r="5768" b="0"/>
          <a:stretch/>
        </p:blipFill>
        <p:spPr>
          <a:xfrm>
            <a:off x="6654960" y="3786120"/>
            <a:ext cx="1531800" cy="746280"/>
          </a:xfrm>
          <a:prstGeom prst="rect">
            <a:avLst/>
          </a:prstGeom>
          <a:ln w="0">
            <a:noFill/>
          </a:ln>
        </p:spPr>
      </p:pic>
      <p:pic>
        <p:nvPicPr>
          <p:cNvPr id="47" name="Picture 8" descr=""/>
          <p:cNvPicPr/>
          <p:nvPr/>
        </p:nvPicPr>
        <p:blipFill>
          <a:blip r:embed="rId6"/>
          <a:srcRect l="32067" t="39442" r="6945" b="0"/>
          <a:stretch/>
        </p:blipFill>
        <p:spPr>
          <a:xfrm>
            <a:off x="6948360" y="4510080"/>
            <a:ext cx="1195560" cy="765360"/>
          </a:xfrm>
          <a:prstGeom prst="rect">
            <a:avLst/>
          </a:prstGeom>
          <a:ln w="0">
            <a:noFill/>
          </a:ln>
        </p:spPr>
      </p:pic>
      <p:pic>
        <p:nvPicPr>
          <p:cNvPr id="48" name="Picture 6" descr=""/>
          <p:cNvPicPr/>
          <p:nvPr/>
        </p:nvPicPr>
        <p:blipFill>
          <a:blip r:embed="rId7"/>
          <a:srcRect l="0" t="43549" r="0" b="0"/>
          <a:stretch/>
        </p:blipFill>
        <p:spPr>
          <a:xfrm>
            <a:off x="6750000" y="5272200"/>
            <a:ext cx="1522440" cy="669960"/>
          </a:xfrm>
          <a:prstGeom prst="rect">
            <a:avLst/>
          </a:prstGeom>
          <a:ln w="0">
            <a:noFill/>
          </a:ln>
        </p:spPr>
      </p:pic>
      <p:pic>
        <p:nvPicPr>
          <p:cNvPr id="49" name="Picture 7" descr=""/>
          <p:cNvPicPr/>
          <p:nvPr/>
        </p:nvPicPr>
        <p:blipFill>
          <a:blip r:embed="rId8"/>
          <a:srcRect l="16926" t="23408" r="0" b="0"/>
          <a:stretch/>
        </p:blipFill>
        <p:spPr>
          <a:xfrm>
            <a:off x="7035840" y="6021360"/>
            <a:ext cx="1131840" cy="797040"/>
          </a:xfrm>
          <a:prstGeom prst="rect">
            <a:avLst/>
          </a:prstGeom>
          <a:ln w="0">
            <a:noFill/>
          </a:ln>
        </p:spPr>
      </p:pic>
      <p:pic>
        <p:nvPicPr>
          <p:cNvPr id="50" name="Picture 6" descr=""/>
          <p:cNvPicPr/>
          <p:nvPr/>
        </p:nvPicPr>
        <p:blipFill>
          <a:blip r:embed="rId9"/>
          <a:srcRect l="64042" t="71383" r="11441" b="0"/>
          <a:stretch/>
        </p:blipFill>
        <p:spPr>
          <a:xfrm>
            <a:off x="6994440" y="6821640"/>
            <a:ext cx="1041480" cy="718920"/>
          </a:xfrm>
          <a:prstGeom prst="rect">
            <a:avLst/>
          </a:prstGeom>
          <a:ln w="0">
            <a:noFill/>
          </a:ln>
        </p:spPr>
      </p:pic>
      <p:pic>
        <p:nvPicPr>
          <p:cNvPr id="51" name="Picture 4" descr=""/>
          <p:cNvPicPr/>
          <p:nvPr/>
        </p:nvPicPr>
        <p:blipFill>
          <a:blip r:embed="rId10"/>
          <a:srcRect l="57129" t="59206" r="0" b="6572"/>
          <a:stretch/>
        </p:blipFill>
        <p:spPr>
          <a:xfrm>
            <a:off x="6716880" y="7535880"/>
            <a:ext cx="1719000" cy="785880"/>
          </a:xfrm>
          <a:prstGeom prst="rect">
            <a:avLst/>
          </a:prstGeom>
          <a:ln w="0">
            <a:noFill/>
          </a:ln>
        </p:spPr>
      </p:pic>
      <p:pic>
        <p:nvPicPr>
          <p:cNvPr id="52" name="Picture 5" descr=""/>
          <p:cNvPicPr/>
          <p:nvPr/>
        </p:nvPicPr>
        <p:blipFill>
          <a:blip r:embed="rId11"/>
          <a:srcRect l="0" t="42618" r="0" b="0"/>
          <a:stretch/>
        </p:blipFill>
        <p:spPr>
          <a:xfrm>
            <a:off x="6773760" y="8334360"/>
            <a:ext cx="1611360" cy="584280"/>
          </a:xfrm>
          <a:prstGeom prst="rect">
            <a:avLst/>
          </a:prstGeom>
          <a:ln w="0">
            <a:noFill/>
          </a:ln>
        </p:spPr>
      </p:pic>
      <p:pic>
        <p:nvPicPr>
          <p:cNvPr id="53" name="Picture 3" descr=""/>
          <p:cNvPicPr/>
          <p:nvPr/>
        </p:nvPicPr>
        <p:blipFill>
          <a:blip r:embed="rId12"/>
          <a:srcRect l="53120" t="62869" r="4778" b="0"/>
          <a:stretch/>
        </p:blipFill>
        <p:spPr>
          <a:xfrm>
            <a:off x="6988320" y="9183600"/>
            <a:ext cx="1190520" cy="571680"/>
          </a:xfrm>
          <a:prstGeom prst="rect">
            <a:avLst/>
          </a:prstGeom>
          <a:ln w="0">
            <a:noFill/>
          </a:ln>
        </p:spPr>
      </p:pic>
      <p:sp>
        <p:nvSpPr>
          <p:cNvPr id="54" name="TextBox 16"/>
          <p:cNvSpPr/>
          <p:nvPr/>
        </p:nvSpPr>
        <p:spPr>
          <a:xfrm>
            <a:off x="6848640" y="554040"/>
            <a:ext cx="14284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맑은 고딕"/>
                <a:ea typeface="맑은 고딕"/>
              </a:rPr>
              <a:t>CNT   6 h   12 h </a:t>
            </a:r>
            <a:endParaRPr b="0" lang="en-US" sz="1100" spc="-1" strike="noStrike">
              <a:solidFill>
                <a:srgbClr val="000000"/>
              </a:solidFill>
              <a:latin typeface="굴림"/>
            </a:endParaRPr>
          </a:p>
        </p:txBody>
      </p:sp>
      <p:pic>
        <p:nvPicPr>
          <p:cNvPr id="55" name="Picture 2" descr=""/>
          <p:cNvPicPr/>
          <p:nvPr/>
        </p:nvPicPr>
        <p:blipFill>
          <a:blip r:embed="rId13"/>
          <a:srcRect l="64914" t="65629" r="1752" b="0"/>
          <a:stretch/>
        </p:blipFill>
        <p:spPr>
          <a:xfrm>
            <a:off x="6654960" y="9536040"/>
            <a:ext cx="1666800" cy="998640"/>
          </a:xfrm>
          <a:prstGeom prst="rect">
            <a:avLst/>
          </a:prstGeom>
          <a:ln w="0">
            <a:noFill/>
          </a:ln>
        </p:spPr>
      </p:pic>
      <p:pic>
        <p:nvPicPr>
          <p:cNvPr id="56" name="Picture 4" descr=""/>
          <p:cNvPicPr/>
          <p:nvPr/>
        </p:nvPicPr>
        <p:blipFill>
          <a:blip r:embed="rId14"/>
          <a:srcRect l="27610" t="38119" r="8952" b="0"/>
          <a:stretch/>
        </p:blipFill>
        <p:spPr>
          <a:xfrm>
            <a:off x="6972480" y="10568160"/>
            <a:ext cx="1226880" cy="730080"/>
          </a:xfrm>
          <a:prstGeom prst="rect">
            <a:avLst/>
          </a:prstGeom>
          <a:ln w="0">
            <a:noFill/>
          </a:ln>
        </p:spPr>
      </p:pic>
      <p:pic>
        <p:nvPicPr>
          <p:cNvPr id="57" name="Picture 6" descr=""/>
          <p:cNvPicPr/>
          <p:nvPr/>
        </p:nvPicPr>
        <p:blipFill>
          <a:blip r:embed="rId15"/>
          <a:srcRect l="62475" t="53404" r="0" b="0"/>
          <a:stretch/>
        </p:blipFill>
        <p:spPr>
          <a:xfrm>
            <a:off x="6972480" y="11234880"/>
            <a:ext cx="1206360" cy="785520"/>
          </a:xfrm>
          <a:prstGeom prst="rect">
            <a:avLst/>
          </a:prstGeom>
          <a:ln w="0">
            <a:noFill/>
          </a:ln>
        </p:spPr>
      </p:pic>
      <p:pic>
        <p:nvPicPr>
          <p:cNvPr id="58" name="Picture 5" descr=""/>
          <p:cNvPicPr/>
          <p:nvPr/>
        </p:nvPicPr>
        <p:blipFill>
          <a:blip r:embed="rId16"/>
          <a:srcRect l="65736" t="56586" r="1048" b="3068"/>
          <a:stretch/>
        </p:blipFill>
        <p:spPr>
          <a:xfrm>
            <a:off x="6978600" y="11961720"/>
            <a:ext cx="1311480" cy="714600"/>
          </a:xfrm>
          <a:prstGeom prst="rect">
            <a:avLst/>
          </a:prstGeom>
          <a:ln w="0">
            <a:noFill/>
          </a:ln>
        </p:spPr>
      </p:pic>
      <p:pic>
        <p:nvPicPr>
          <p:cNvPr id="59" name="Picture 4" descr=""/>
          <p:cNvPicPr/>
          <p:nvPr/>
        </p:nvPicPr>
        <p:blipFill>
          <a:blip r:embed="rId17"/>
          <a:srcRect l="68059" t="66371" r="4053" b="0"/>
          <a:stretch/>
        </p:blipFill>
        <p:spPr>
          <a:xfrm>
            <a:off x="7004160" y="12763440"/>
            <a:ext cx="1158840" cy="720720"/>
          </a:xfrm>
          <a:prstGeom prst="rect">
            <a:avLst/>
          </a:prstGeom>
          <a:ln w="0">
            <a:noFill/>
          </a:ln>
        </p:spPr>
      </p:pic>
      <p:pic>
        <p:nvPicPr>
          <p:cNvPr id="60" name="Picture 7" descr=""/>
          <p:cNvPicPr/>
          <p:nvPr/>
        </p:nvPicPr>
        <p:blipFill>
          <a:blip r:embed="rId18"/>
          <a:srcRect l="65598" t="75063" r="0" b="0"/>
          <a:stretch/>
        </p:blipFill>
        <p:spPr>
          <a:xfrm>
            <a:off x="6978600" y="13690440"/>
            <a:ext cx="1343160" cy="7081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1" name=""/>
          <p:cNvGraphicFramePr/>
          <p:nvPr/>
        </p:nvGraphicFramePr>
        <p:xfrm>
          <a:off x="176040" y="216000"/>
          <a:ext cx="8320320" cy="5794200"/>
        </p:xfrm>
        <a:graphic>
          <a:graphicData uri="http://schemas.openxmlformats.org/drawingml/2006/table">
            <a:tbl>
              <a:tblPr/>
              <a:tblGrid>
                <a:gridCol w="781200"/>
                <a:gridCol w="1257480"/>
                <a:gridCol w="2195280"/>
                <a:gridCol w="954000"/>
                <a:gridCol w="1247760"/>
                <a:gridCol w="1884600"/>
              </a:tblGrid>
              <a:tr h="736560"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Spot No: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Accession No: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Protein nam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맑은 고딕"/>
                          <a:ea typeface="맑은 고딕"/>
                        </a:rPr>
                        <a:t>p- valu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Fold chang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맑은 고딕"/>
                          <a:ea typeface="맑은 고딕"/>
                        </a:rPr>
                        <a:t>Relative spot intensity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011240"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1702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KCTD1_RAT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BTB/POZ domain –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containing protein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  <a:ea typeface="맑은 고딕"/>
                        </a:rPr>
                        <a:t>5.794e-004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2.5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011240"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1645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CULU_RAT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Calumenin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  <a:ea typeface="맑은 고딕"/>
                        </a:rPr>
                        <a:t>0.004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1.8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012680"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1586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PHB2_RAT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Prohibitin 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0.00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2.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011240"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1690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VIME_RAT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Vimentin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  <a:ea typeface="맑은 고딕"/>
                        </a:rPr>
                        <a:t>0.037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1.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011240"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3142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G3PT_RAT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Glyceraldehyde 3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phosphate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dehydrogenas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  <a:ea typeface="맑은 고딕"/>
                        </a:rPr>
                        <a:t>0.01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2.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5480" marR="15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pic>
        <p:nvPicPr>
          <p:cNvPr id="62" name="Picture 6" descr=""/>
          <p:cNvPicPr/>
          <p:nvPr/>
        </p:nvPicPr>
        <p:blipFill>
          <a:blip r:embed="rId1"/>
          <a:srcRect l="16855" t="39860" r="8563" b="0"/>
          <a:stretch/>
        </p:blipFill>
        <p:spPr>
          <a:xfrm>
            <a:off x="7068960" y="1311120"/>
            <a:ext cx="1108080" cy="746280"/>
          </a:xfrm>
          <a:prstGeom prst="rect">
            <a:avLst/>
          </a:prstGeom>
          <a:ln w="0">
            <a:noFill/>
          </a:ln>
        </p:spPr>
      </p:pic>
      <p:pic>
        <p:nvPicPr>
          <p:cNvPr id="63" name="Picture 5" descr=""/>
          <p:cNvPicPr/>
          <p:nvPr/>
        </p:nvPicPr>
        <p:blipFill>
          <a:blip r:embed="rId2"/>
          <a:srcRect l="72788" t="79126" r="0" b="0"/>
          <a:stretch/>
        </p:blipFill>
        <p:spPr>
          <a:xfrm>
            <a:off x="7032600" y="2414520"/>
            <a:ext cx="1220760" cy="582840"/>
          </a:xfrm>
          <a:prstGeom prst="rect">
            <a:avLst/>
          </a:prstGeom>
          <a:ln w="0">
            <a:noFill/>
          </a:ln>
        </p:spPr>
      </p:pic>
      <p:pic>
        <p:nvPicPr>
          <p:cNvPr id="64" name="Picture 3" descr=""/>
          <p:cNvPicPr/>
          <p:nvPr/>
        </p:nvPicPr>
        <p:blipFill>
          <a:blip r:embed="rId3"/>
          <a:srcRect l="24628" t="41801" r="7559" b="0"/>
          <a:stretch/>
        </p:blipFill>
        <p:spPr>
          <a:xfrm>
            <a:off x="7137360" y="4264200"/>
            <a:ext cx="1085760" cy="807840"/>
          </a:xfrm>
          <a:prstGeom prst="rect">
            <a:avLst/>
          </a:prstGeom>
          <a:ln w="0">
            <a:noFill/>
          </a:ln>
        </p:spPr>
      </p:pic>
      <p:pic>
        <p:nvPicPr>
          <p:cNvPr id="65" name="Picture 4" descr=""/>
          <p:cNvPicPr/>
          <p:nvPr/>
        </p:nvPicPr>
        <p:blipFill>
          <a:blip r:embed="rId4"/>
          <a:srcRect l="65598" t="55088" r="0" b="13785"/>
          <a:stretch/>
        </p:blipFill>
        <p:spPr>
          <a:xfrm>
            <a:off x="6983280" y="3260880"/>
            <a:ext cx="1500480" cy="815760"/>
          </a:xfrm>
          <a:prstGeom prst="rect">
            <a:avLst/>
          </a:prstGeom>
          <a:ln w="0">
            <a:noFill/>
          </a:ln>
        </p:spPr>
      </p:pic>
      <p:pic>
        <p:nvPicPr>
          <p:cNvPr id="66" name="Picture 2" descr=""/>
          <p:cNvPicPr/>
          <p:nvPr/>
        </p:nvPicPr>
        <p:blipFill>
          <a:blip r:embed="rId5"/>
          <a:srcRect l="21618" t="33352" r="9461" b="0"/>
          <a:stretch/>
        </p:blipFill>
        <p:spPr>
          <a:xfrm>
            <a:off x="7164360" y="5356080"/>
            <a:ext cx="1143000" cy="819360"/>
          </a:xfrm>
          <a:prstGeom prst="rect">
            <a:avLst/>
          </a:prstGeom>
          <a:ln w="0">
            <a:noFill/>
          </a:ln>
        </p:spPr>
      </p:pic>
      <p:sp>
        <p:nvSpPr>
          <p:cNvPr id="67" name="TextBox 9"/>
          <p:cNvSpPr/>
          <p:nvPr/>
        </p:nvSpPr>
        <p:spPr>
          <a:xfrm>
            <a:off x="6943680" y="674640"/>
            <a:ext cx="14288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맑은 고딕"/>
                <a:ea typeface="맑은 고딕"/>
              </a:rPr>
              <a:t>CNT   6 h   12 h </a:t>
            </a:r>
            <a:endParaRPr b="0" lang="en-US" sz="11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01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5-12T15:47:47Z</dcterms:created>
  <dc:creator>1</dc:creator>
  <dc:description/>
  <dc:language>en-US</dc:language>
  <cp:lastModifiedBy>USER</cp:lastModifiedBy>
  <dcterms:modified xsi:type="dcterms:W3CDTF">2015-07-01T15:44:02Z</dcterms:modified>
  <cp:revision>15</cp:revision>
  <dc:subject/>
  <dc:title>슬라이드 1</dc:title>
</cp:coreProperties>
</file>